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3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927" autoAdjust="0"/>
    <p:restoredTop sz="94660"/>
  </p:normalViewPr>
  <p:slideViewPr>
    <p:cSldViewPr snapToGrid="0">
      <p:cViewPr varScale="1">
        <p:scale>
          <a:sx n="45" d="100"/>
          <a:sy n="45" d="100"/>
        </p:scale>
        <p:origin x="19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A86657-A7F8-4317-B62B-26FBC9188DB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239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38847" y="1053727"/>
            <a:ext cx="6480903" cy="1774147"/>
            <a:chOff x="538847" y="2646307"/>
            <a:chExt cx="6480903" cy="1774147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93" t="8082" r="52439" b="57420"/>
            <a:stretch/>
          </p:blipFill>
          <p:spPr>
            <a:xfrm>
              <a:off x="2698533" y="2648863"/>
              <a:ext cx="2162435" cy="177159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96" t="8012" r="3507" b="57773"/>
            <a:stretch/>
          </p:blipFill>
          <p:spPr>
            <a:xfrm>
              <a:off x="539750" y="2648863"/>
              <a:ext cx="2158782" cy="177159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8" t="53110" r="51644" b="12604"/>
            <a:stretch/>
          </p:blipFill>
          <p:spPr>
            <a:xfrm>
              <a:off x="4857314" y="2648863"/>
              <a:ext cx="2162436" cy="177159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538847" y="2646307"/>
              <a:ext cx="284179" cy="23993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</a:t>
              </a:r>
              <a:endParaRPr lang="zh-CN" altLang="en-US" sz="1000" dirty="0">
                <a:solidFill>
                  <a:schemeClr val="bg1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xmlns="" id="{2264EA60-B72B-42CB-AC68-E016DADC16C0}"/>
                </a:ext>
              </a:extLst>
            </p:cNvPr>
            <p:cNvSpPr txBox="1"/>
            <p:nvPr/>
          </p:nvSpPr>
          <p:spPr>
            <a:xfrm>
              <a:off x="2708003" y="2650609"/>
              <a:ext cx="267077" cy="23993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4858247" y="2650878"/>
              <a:ext cx="298386" cy="23993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</a:t>
              </a:r>
              <a:endParaRPr lang="zh-CN" altLang="en-US" sz="1000" dirty="0">
                <a:solidFill>
                  <a:schemeClr val="bg1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82646" y="3010448"/>
            <a:ext cx="661157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Calculation of TBR value based on SUV measurements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-c: Three high 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-FDG-uptaking lesions (respectively at right lobe, left medial lobe and left lateral lobe) in this patient; 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: CT; 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: PET;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: Measurement of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t LME and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t background liver in the same PET/CT slide;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ample: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or lesions at left medial lobe and left lateral lobes respectively were 13.395 and 13.304, while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or background liver was 2.337, thus, TBR=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V</a:t>
            </a:r>
            <a:r>
              <a:rPr lang="en-US" altLang="zh-CN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e</a:t>
            </a:r>
            <a:r>
              <a:rPr lang="en-US" altLang="zh-CN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rresponding lesion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spectively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13.395/2.337=5.73 and 13.304/2.337=5.69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7145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111</Words>
  <Application>Microsoft Office PowerPoint</Application>
  <PresentationFormat>Custom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黑体</vt:lpstr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1:26Z</dcterms:modified>
</cp:coreProperties>
</file>